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432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EAED4E-39FF-4178-B5CA-4ECF063D054D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ABD73E-FDA4-47AF-98E3-869BC1E19A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966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9057A3-99BE-4E70-94AF-0CBCF0A0EBE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82375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8595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2904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6136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4308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9251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2956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6637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3796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1925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6766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6846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DDAA48-5AE4-4ABE-AC41-D5BE8455D11C}" type="datetimeFigureOut">
              <a:rPr lang="de-DE" smtClean="0"/>
              <a:t>05.04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6A25B-E295-4E57-9D59-10B04EE998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5992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 rot="16200000">
            <a:off x="153636" y="3446379"/>
            <a:ext cx="1470179" cy="340685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  <a:prstDash val="sysDot"/>
          </a:ln>
        </p:spPr>
        <p:txBody>
          <a:bodyPr wrap="square" lIns="78309" tIns="39155" rIns="78309" bIns="39155" rtlCol="0">
            <a:spAutoFit/>
          </a:bodyPr>
          <a:lstStyle/>
          <a:p>
            <a:r>
              <a:rPr lang="de-AT" sz="1700" dirty="0" smtClean="0"/>
              <a:t>FIGO </a:t>
            </a:r>
            <a:r>
              <a:rPr lang="de-AT" sz="1700" dirty="0" err="1" smtClean="0"/>
              <a:t>stage</a:t>
            </a:r>
            <a:r>
              <a:rPr lang="de-AT" sz="1700" dirty="0" smtClean="0"/>
              <a:t> I-II</a:t>
            </a:r>
            <a:endParaRPr lang="de-DE" sz="1700" dirty="0"/>
          </a:p>
        </p:txBody>
      </p:sp>
      <p:sp>
        <p:nvSpPr>
          <p:cNvPr id="8" name="Textfeld 7"/>
          <p:cNvSpPr txBox="1"/>
          <p:nvPr/>
        </p:nvSpPr>
        <p:spPr>
          <a:xfrm rot="16200000">
            <a:off x="90485" y="5162473"/>
            <a:ext cx="1591497" cy="340685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  <a:prstDash val="sysDot"/>
          </a:ln>
        </p:spPr>
        <p:txBody>
          <a:bodyPr wrap="square" lIns="78309" tIns="39155" rIns="78309" bIns="39155" rtlCol="0">
            <a:spAutoFit/>
          </a:bodyPr>
          <a:lstStyle/>
          <a:p>
            <a:r>
              <a:rPr lang="de-AT" sz="1700" dirty="0" smtClean="0"/>
              <a:t>FIGO </a:t>
            </a:r>
            <a:r>
              <a:rPr lang="de-AT" sz="1700" dirty="0" err="1" smtClean="0"/>
              <a:t>stage</a:t>
            </a:r>
            <a:r>
              <a:rPr lang="de-AT" sz="1700" dirty="0" smtClean="0"/>
              <a:t> III-IV</a:t>
            </a:r>
            <a:endParaRPr lang="de-DE" sz="1700" dirty="0"/>
          </a:p>
        </p:txBody>
      </p:sp>
      <p:sp>
        <p:nvSpPr>
          <p:cNvPr id="9" name="Textfeld 8"/>
          <p:cNvSpPr txBox="1"/>
          <p:nvPr/>
        </p:nvSpPr>
        <p:spPr>
          <a:xfrm rot="16200000">
            <a:off x="143660" y="1757692"/>
            <a:ext cx="1485148" cy="340685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  <a:prstDash val="sysDot"/>
          </a:ln>
        </p:spPr>
        <p:txBody>
          <a:bodyPr wrap="square" lIns="78309" tIns="39155" rIns="78309" bIns="39155" rtlCol="0">
            <a:spAutoFit/>
          </a:bodyPr>
          <a:lstStyle/>
          <a:p>
            <a:pPr algn="ctr"/>
            <a:r>
              <a:rPr lang="de-AT" sz="1700" dirty="0"/>
              <a:t>All </a:t>
            </a:r>
            <a:r>
              <a:rPr lang="de-AT" sz="1700" dirty="0" err="1"/>
              <a:t>cohort</a:t>
            </a:r>
            <a:endParaRPr lang="de-DE" sz="1700" dirty="0"/>
          </a:p>
        </p:txBody>
      </p:sp>
      <p:grpSp>
        <p:nvGrpSpPr>
          <p:cNvPr id="2" name="Gruppieren 1"/>
          <p:cNvGrpSpPr/>
          <p:nvPr/>
        </p:nvGrpSpPr>
        <p:grpSpPr>
          <a:xfrm>
            <a:off x="1012944" y="573013"/>
            <a:ext cx="6871423" cy="5736307"/>
            <a:chOff x="3846849" y="287635"/>
            <a:chExt cx="7037589" cy="5781454"/>
          </a:xfrm>
        </p:grpSpPr>
        <p:pic>
          <p:nvPicPr>
            <p:cNvPr id="7181" name="Picture 1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9" t="6313" r="24270" b="6759"/>
            <a:stretch/>
          </p:blipFill>
          <p:spPr bwMode="auto">
            <a:xfrm>
              <a:off x="9388983" y="4297549"/>
              <a:ext cx="1495455" cy="16067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80" name="Picture 1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78" t="6312" r="24095" b="6854"/>
            <a:stretch/>
          </p:blipFill>
          <p:spPr bwMode="auto">
            <a:xfrm>
              <a:off x="7549729" y="4268968"/>
              <a:ext cx="1598601" cy="16161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79" name="Picture 11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27" t="6313" r="24618" b="6759"/>
            <a:stretch/>
          </p:blipFill>
          <p:spPr bwMode="auto">
            <a:xfrm>
              <a:off x="7542634" y="2629404"/>
              <a:ext cx="1605697" cy="15758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78" name="Picture 10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27" t="6313" r="24445" b="6759"/>
            <a:stretch/>
          </p:blipFill>
          <p:spPr bwMode="auto">
            <a:xfrm>
              <a:off x="9383594" y="2629403"/>
              <a:ext cx="1500844" cy="15758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77" name="Picture 9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53" t="6313" r="24444" b="6257"/>
            <a:stretch/>
          </p:blipFill>
          <p:spPr bwMode="auto">
            <a:xfrm>
              <a:off x="5838463" y="4282889"/>
              <a:ext cx="1475644" cy="16022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76" name="Picture 8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04" t="6313" r="24618" b="6257"/>
            <a:stretch/>
          </p:blipFill>
          <p:spPr bwMode="auto">
            <a:xfrm>
              <a:off x="4073922" y="4282838"/>
              <a:ext cx="1536092" cy="16214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75" name="Picture 7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04" t="6313" r="24618" b="7494"/>
            <a:stretch/>
          </p:blipFill>
          <p:spPr bwMode="auto">
            <a:xfrm>
              <a:off x="4051847" y="2628819"/>
              <a:ext cx="1558168" cy="15565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74" name="Picture 6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52" t="6312" r="24270" b="6854"/>
            <a:stretch/>
          </p:blipFill>
          <p:spPr bwMode="auto">
            <a:xfrm>
              <a:off x="5814442" y="2628819"/>
              <a:ext cx="1499665" cy="1556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4" name="Picture 2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09"/>
            <a:stretch/>
          </p:blipFill>
          <p:spPr bwMode="auto">
            <a:xfrm>
              <a:off x="3889976" y="886346"/>
              <a:ext cx="6994462" cy="16335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feld 10"/>
            <p:cNvSpPr txBox="1"/>
            <p:nvPr/>
          </p:nvSpPr>
          <p:spPr>
            <a:xfrm>
              <a:off x="4158258" y="287635"/>
              <a:ext cx="3155850" cy="372239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AT" dirty="0" smtClean="0"/>
                <a:t>Type I</a:t>
              </a:r>
              <a:endParaRPr lang="de-DE" dirty="0"/>
            </a:p>
          </p:txBody>
        </p:sp>
        <p:grpSp>
          <p:nvGrpSpPr>
            <p:cNvPr id="20" name="Gruppieren 19"/>
            <p:cNvGrpSpPr/>
            <p:nvPr/>
          </p:nvGrpSpPr>
          <p:grpSpPr>
            <a:xfrm>
              <a:off x="7342272" y="4270610"/>
              <a:ext cx="1806061" cy="1769150"/>
              <a:chOff x="4144857" y="-1520990"/>
              <a:chExt cx="1813601" cy="1769150"/>
            </a:xfrm>
          </p:grpSpPr>
          <p:sp>
            <p:nvSpPr>
              <p:cNvPr id="90" name="Textfeld 89"/>
              <p:cNvSpPr txBox="1"/>
              <p:nvPr/>
            </p:nvSpPr>
            <p:spPr>
              <a:xfrm rot="16200000">
                <a:off x="3533581" y="-909714"/>
                <a:ext cx="1520990" cy="298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Disease</a:t>
                </a:r>
                <a:r>
                  <a:rPr lang="de-AT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 Free </a:t>
                </a:r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urvival</a:t>
                </a:r>
                <a:endParaRPr lang="de-DE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91" name="Textfeld 90"/>
              <p:cNvSpPr txBox="1"/>
              <p:nvPr/>
            </p:nvSpPr>
            <p:spPr>
              <a:xfrm>
                <a:off x="4761854" y="1"/>
                <a:ext cx="718378" cy="24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Time (</a:t>
                </a:r>
                <a:r>
                  <a:rPr lang="de-AT" sz="5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months</a:t>
                </a:r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)</a:t>
                </a:r>
                <a:endParaRPr lang="de-DE" sz="5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92" name="Textfeld 91"/>
              <p:cNvSpPr txBox="1"/>
              <p:nvPr/>
            </p:nvSpPr>
            <p:spPr>
              <a:xfrm>
                <a:off x="5205310" y="-288429"/>
                <a:ext cx="753148" cy="403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b="1" dirty="0"/>
                  <a:t>p=0.459</a:t>
                </a:r>
                <a:endParaRPr lang="de-DE" sz="1000" b="1" dirty="0"/>
              </a:p>
            </p:txBody>
          </p:sp>
        </p:grpSp>
        <p:sp>
          <p:nvSpPr>
            <p:cNvPr id="43" name="Textfeld 42"/>
            <p:cNvSpPr txBox="1"/>
            <p:nvPr/>
          </p:nvSpPr>
          <p:spPr>
            <a:xfrm rot="16200000">
              <a:off x="3266358" y="1475596"/>
              <a:ext cx="1520990" cy="2971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Disease</a:t>
              </a:r>
              <a:r>
                <a:rPr lang="de-AT" sz="90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 Free </a:t>
              </a:r>
              <a:r>
                <a:rPr lang="de-AT" sz="900" dirty="0" err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survival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4490778" y="2384691"/>
              <a:ext cx="680107" cy="2481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50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Time (</a:t>
              </a:r>
              <a:r>
                <a:rPr lang="de-AT" sz="500" dirty="0" err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months</a:t>
              </a:r>
              <a:r>
                <a:rPr lang="de-AT" sz="50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)</a:t>
              </a:r>
              <a:endParaRPr lang="de-DE" sz="5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4920372" y="2133225"/>
              <a:ext cx="713021" cy="403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/>
                <a:t>p=0.431</a:t>
              </a:r>
              <a:endParaRPr lang="de-DE" sz="1000" b="1" dirty="0"/>
            </a:p>
          </p:txBody>
        </p:sp>
        <p:sp>
          <p:nvSpPr>
            <p:cNvPr id="46" name="Textfeld 45"/>
            <p:cNvSpPr txBox="1"/>
            <p:nvPr/>
          </p:nvSpPr>
          <p:spPr>
            <a:xfrm rot="16200000">
              <a:off x="3234952" y="3203788"/>
              <a:ext cx="1520990" cy="2971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Disease</a:t>
              </a:r>
              <a:r>
                <a:rPr lang="de-AT" sz="90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 Free </a:t>
              </a:r>
              <a:r>
                <a:rPr lang="de-AT" sz="900" dirty="0" err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survival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4500876" y="4112883"/>
              <a:ext cx="680107" cy="2481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50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Time (</a:t>
              </a:r>
              <a:r>
                <a:rPr lang="de-AT" sz="500" dirty="0" err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months</a:t>
              </a:r>
              <a:r>
                <a:rPr lang="de-AT" sz="50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)</a:t>
              </a:r>
              <a:endParaRPr lang="de-DE" sz="5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4935063" y="3816027"/>
              <a:ext cx="713021" cy="403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/>
                <a:t>p=0.108</a:t>
              </a:r>
            </a:p>
          </p:txBody>
        </p:sp>
        <p:sp>
          <p:nvSpPr>
            <p:cNvPr id="49" name="Textfeld 48"/>
            <p:cNvSpPr txBox="1"/>
            <p:nvPr/>
          </p:nvSpPr>
          <p:spPr>
            <a:xfrm rot="16200000">
              <a:off x="5034141" y="1475596"/>
              <a:ext cx="1520989" cy="2971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Overall </a:t>
              </a:r>
              <a:r>
                <a:rPr lang="de-AT" sz="900" dirty="0" err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survival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6246156" y="2401740"/>
              <a:ext cx="680107" cy="2481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50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Time (</a:t>
              </a:r>
              <a:r>
                <a:rPr lang="de-AT" sz="500" dirty="0" err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months</a:t>
              </a:r>
              <a:r>
                <a:rPr lang="de-AT" sz="50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)</a:t>
              </a:r>
              <a:endParaRPr lang="de-DE" sz="5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6588723" y="2124741"/>
              <a:ext cx="695482" cy="403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/>
                <a:t>p=0.881</a:t>
              </a:r>
              <a:endParaRPr lang="de-DE" sz="1000" b="1" dirty="0"/>
            </a:p>
          </p:txBody>
        </p:sp>
        <p:grpSp>
          <p:nvGrpSpPr>
            <p:cNvPr id="53" name="Gruppieren 52"/>
            <p:cNvGrpSpPr/>
            <p:nvPr/>
          </p:nvGrpSpPr>
          <p:grpSpPr>
            <a:xfrm>
              <a:off x="5629940" y="2597378"/>
              <a:ext cx="1654264" cy="1786198"/>
              <a:chOff x="2152305" y="-1584572"/>
              <a:chExt cx="1747357" cy="1786198"/>
            </a:xfrm>
          </p:grpSpPr>
          <p:sp>
            <p:nvSpPr>
              <p:cNvPr id="87" name="Textfeld 86"/>
              <p:cNvSpPr txBox="1"/>
              <p:nvPr/>
            </p:nvSpPr>
            <p:spPr>
              <a:xfrm rot="16200000">
                <a:off x="1548771" y="-981038"/>
                <a:ext cx="1520989" cy="3139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Overall </a:t>
                </a:r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urvival</a:t>
                </a:r>
                <a:endParaRPr lang="de-DE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88" name="Textfeld 87"/>
              <p:cNvSpPr txBox="1"/>
              <p:nvPr/>
            </p:nvSpPr>
            <p:spPr>
              <a:xfrm>
                <a:off x="2813973" y="-46533"/>
                <a:ext cx="718378" cy="24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Time (</a:t>
                </a:r>
                <a:r>
                  <a:rPr lang="de-AT" sz="5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months</a:t>
                </a:r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)</a:t>
                </a:r>
                <a:endParaRPr lang="de-DE" sz="5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89" name="Textfeld 88"/>
              <p:cNvSpPr txBox="1"/>
              <p:nvPr/>
            </p:nvSpPr>
            <p:spPr>
              <a:xfrm>
                <a:off x="3165043" y="-348996"/>
                <a:ext cx="734619" cy="403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b="1" dirty="0"/>
                  <a:t>p=0.617</a:t>
                </a:r>
                <a:endParaRPr lang="de-DE" sz="1000" b="1" dirty="0"/>
              </a:p>
            </p:txBody>
          </p:sp>
        </p:grpSp>
        <p:grpSp>
          <p:nvGrpSpPr>
            <p:cNvPr id="55" name="Gruppieren 54"/>
            <p:cNvGrpSpPr/>
            <p:nvPr/>
          </p:nvGrpSpPr>
          <p:grpSpPr>
            <a:xfrm>
              <a:off x="5646037" y="4248076"/>
              <a:ext cx="1638167" cy="1786198"/>
              <a:chOff x="2169308" y="-1584572"/>
              <a:chExt cx="1730354" cy="1786198"/>
            </a:xfrm>
          </p:grpSpPr>
          <p:sp>
            <p:nvSpPr>
              <p:cNvPr id="84" name="Textfeld 83"/>
              <p:cNvSpPr txBox="1"/>
              <p:nvPr/>
            </p:nvSpPr>
            <p:spPr>
              <a:xfrm rot="16200000">
                <a:off x="1565774" y="-981038"/>
                <a:ext cx="1520989" cy="3139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Overall </a:t>
                </a:r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urvival</a:t>
                </a:r>
                <a:endParaRPr lang="de-DE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85" name="Textfeld 84"/>
              <p:cNvSpPr txBox="1"/>
              <p:nvPr/>
            </p:nvSpPr>
            <p:spPr>
              <a:xfrm>
                <a:off x="2813973" y="-46533"/>
                <a:ext cx="718378" cy="24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Time (</a:t>
                </a:r>
                <a:r>
                  <a:rPr lang="de-AT" sz="5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months</a:t>
                </a:r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)</a:t>
                </a:r>
                <a:endParaRPr lang="de-DE" sz="5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86" name="Textfeld 85"/>
              <p:cNvSpPr txBox="1"/>
              <p:nvPr/>
            </p:nvSpPr>
            <p:spPr>
              <a:xfrm>
                <a:off x="3165043" y="-348996"/>
                <a:ext cx="734619" cy="403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b="1" dirty="0"/>
                  <a:t>p=0.195</a:t>
                </a:r>
                <a:endParaRPr lang="de-DE" sz="1000" b="1" dirty="0"/>
              </a:p>
            </p:txBody>
          </p:sp>
        </p:grpSp>
        <p:grpSp>
          <p:nvGrpSpPr>
            <p:cNvPr id="57" name="Gruppieren 56"/>
            <p:cNvGrpSpPr/>
            <p:nvPr/>
          </p:nvGrpSpPr>
          <p:grpSpPr>
            <a:xfrm>
              <a:off x="3876056" y="4270610"/>
              <a:ext cx="1757676" cy="1769150"/>
              <a:chOff x="4101871" y="-1520990"/>
              <a:chExt cx="1856587" cy="1769150"/>
            </a:xfrm>
          </p:grpSpPr>
          <p:sp>
            <p:nvSpPr>
              <p:cNvPr id="81" name="Textfeld 80"/>
              <p:cNvSpPr txBox="1"/>
              <p:nvPr/>
            </p:nvSpPr>
            <p:spPr>
              <a:xfrm rot="16200000">
                <a:off x="3498337" y="-917456"/>
                <a:ext cx="1520990" cy="3139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Disease</a:t>
                </a:r>
                <a:r>
                  <a:rPr lang="de-AT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 Free </a:t>
                </a:r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urvival</a:t>
                </a:r>
                <a:endParaRPr lang="de-DE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82" name="Textfeld 81"/>
              <p:cNvSpPr txBox="1"/>
              <p:nvPr/>
            </p:nvSpPr>
            <p:spPr>
              <a:xfrm>
                <a:off x="4761853" y="1"/>
                <a:ext cx="718379" cy="24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Time (</a:t>
                </a:r>
                <a:r>
                  <a:rPr lang="de-AT" sz="5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months</a:t>
                </a:r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)</a:t>
                </a:r>
                <a:endParaRPr lang="de-DE" sz="5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83" name="Textfeld 82"/>
              <p:cNvSpPr txBox="1"/>
              <p:nvPr/>
            </p:nvSpPr>
            <p:spPr>
              <a:xfrm>
                <a:off x="5205311" y="-288429"/>
                <a:ext cx="753147" cy="403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b="1" dirty="0"/>
                  <a:t>p=0.123</a:t>
                </a:r>
                <a:endParaRPr lang="de-DE" sz="1000" b="1" dirty="0"/>
              </a:p>
            </p:txBody>
          </p:sp>
        </p:grpSp>
        <p:grpSp>
          <p:nvGrpSpPr>
            <p:cNvPr id="58" name="Gruppieren 57"/>
            <p:cNvGrpSpPr/>
            <p:nvPr/>
          </p:nvGrpSpPr>
          <p:grpSpPr>
            <a:xfrm>
              <a:off x="7344470" y="897212"/>
              <a:ext cx="1803862" cy="1769150"/>
              <a:chOff x="4147065" y="-1520990"/>
              <a:chExt cx="1811393" cy="1769150"/>
            </a:xfrm>
          </p:grpSpPr>
          <p:sp>
            <p:nvSpPr>
              <p:cNvPr id="78" name="Textfeld 77"/>
              <p:cNvSpPr txBox="1"/>
              <p:nvPr/>
            </p:nvSpPr>
            <p:spPr>
              <a:xfrm rot="16200000">
                <a:off x="3535789" y="-909714"/>
                <a:ext cx="1520990" cy="298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Disease</a:t>
                </a:r>
                <a:r>
                  <a:rPr lang="de-AT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 Free </a:t>
                </a:r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urvival</a:t>
                </a:r>
                <a:endParaRPr lang="de-DE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79" name="Textfeld 78"/>
              <p:cNvSpPr txBox="1"/>
              <p:nvPr/>
            </p:nvSpPr>
            <p:spPr>
              <a:xfrm>
                <a:off x="4761854" y="1"/>
                <a:ext cx="718378" cy="24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Time (</a:t>
                </a:r>
                <a:r>
                  <a:rPr lang="de-AT" sz="5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months</a:t>
                </a:r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)</a:t>
                </a:r>
                <a:endParaRPr lang="de-DE" sz="5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80" name="Textfeld 79"/>
              <p:cNvSpPr txBox="1"/>
              <p:nvPr/>
            </p:nvSpPr>
            <p:spPr>
              <a:xfrm>
                <a:off x="5205310" y="-288429"/>
                <a:ext cx="753148" cy="403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b="1" dirty="0"/>
                  <a:t>p=0.577</a:t>
                </a:r>
                <a:endParaRPr lang="de-DE" sz="1000" b="1" dirty="0"/>
              </a:p>
            </p:txBody>
          </p:sp>
        </p:grpSp>
        <p:grpSp>
          <p:nvGrpSpPr>
            <p:cNvPr id="59" name="Gruppieren 58"/>
            <p:cNvGrpSpPr/>
            <p:nvPr/>
          </p:nvGrpSpPr>
          <p:grpSpPr>
            <a:xfrm>
              <a:off x="9142199" y="904902"/>
              <a:ext cx="1699844" cy="1786198"/>
              <a:chOff x="2192721" y="-1584572"/>
              <a:chExt cx="1706941" cy="1786198"/>
            </a:xfrm>
          </p:grpSpPr>
          <p:sp>
            <p:nvSpPr>
              <p:cNvPr id="75" name="Textfeld 74"/>
              <p:cNvSpPr txBox="1"/>
              <p:nvPr/>
            </p:nvSpPr>
            <p:spPr>
              <a:xfrm rot="16200000">
                <a:off x="1581445" y="-973296"/>
                <a:ext cx="1520989" cy="298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Overall </a:t>
                </a:r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urvival</a:t>
                </a:r>
                <a:endParaRPr lang="de-DE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76" name="Textfeld 75"/>
              <p:cNvSpPr txBox="1"/>
              <p:nvPr/>
            </p:nvSpPr>
            <p:spPr>
              <a:xfrm>
                <a:off x="2813973" y="-46533"/>
                <a:ext cx="718377" cy="24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Time (</a:t>
                </a:r>
                <a:r>
                  <a:rPr lang="de-AT" sz="5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months</a:t>
                </a:r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)</a:t>
                </a:r>
                <a:endParaRPr lang="de-DE" sz="5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77" name="Textfeld 76"/>
              <p:cNvSpPr txBox="1"/>
              <p:nvPr/>
            </p:nvSpPr>
            <p:spPr>
              <a:xfrm>
                <a:off x="3165042" y="-348996"/>
                <a:ext cx="734620" cy="403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b="1" dirty="0"/>
                  <a:t>p=0.212</a:t>
                </a:r>
                <a:endParaRPr lang="de-DE" sz="1000" b="1" dirty="0"/>
              </a:p>
            </p:txBody>
          </p:sp>
        </p:grpSp>
        <p:grpSp>
          <p:nvGrpSpPr>
            <p:cNvPr id="61" name="Gruppieren 60"/>
            <p:cNvGrpSpPr/>
            <p:nvPr/>
          </p:nvGrpSpPr>
          <p:grpSpPr>
            <a:xfrm>
              <a:off x="9186005" y="2604668"/>
              <a:ext cx="1665853" cy="1786198"/>
              <a:chOff x="2226854" y="-1584572"/>
              <a:chExt cx="1672808" cy="1786198"/>
            </a:xfrm>
          </p:grpSpPr>
          <p:sp>
            <p:nvSpPr>
              <p:cNvPr id="72" name="Textfeld 71"/>
              <p:cNvSpPr txBox="1"/>
              <p:nvPr/>
            </p:nvSpPr>
            <p:spPr>
              <a:xfrm rot="16200000">
                <a:off x="1615578" y="-973296"/>
                <a:ext cx="1520989" cy="298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Overall </a:t>
                </a:r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urvival</a:t>
                </a:r>
                <a:endParaRPr lang="de-DE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73" name="Textfeld 72"/>
              <p:cNvSpPr txBox="1"/>
              <p:nvPr/>
            </p:nvSpPr>
            <p:spPr>
              <a:xfrm>
                <a:off x="2813973" y="-46533"/>
                <a:ext cx="718377" cy="24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Time (</a:t>
                </a:r>
                <a:r>
                  <a:rPr lang="de-AT" sz="5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months</a:t>
                </a:r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)</a:t>
                </a:r>
                <a:endParaRPr lang="de-DE" sz="5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74" name="Textfeld 73"/>
              <p:cNvSpPr txBox="1"/>
              <p:nvPr/>
            </p:nvSpPr>
            <p:spPr>
              <a:xfrm>
                <a:off x="3165042" y="-348996"/>
                <a:ext cx="734620" cy="403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b="1" dirty="0"/>
                  <a:t>p=0.457</a:t>
                </a:r>
                <a:endParaRPr lang="de-DE" sz="1000" b="1" dirty="0"/>
              </a:p>
            </p:txBody>
          </p:sp>
        </p:grpSp>
        <p:grpSp>
          <p:nvGrpSpPr>
            <p:cNvPr id="63" name="Gruppieren 62"/>
            <p:cNvGrpSpPr/>
            <p:nvPr/>
          </p:nvGrpSpPr>
          <p:grpSpPr>
            <a:xfrm>
              <a:off x="7330799" y="2614426"/>
              <a:ext cx="1871878" cy="1769150"/>
              <a:chOff x="4078765" y="-1520990"/>
              <a:chExt cx="1879693" cy="1769150"/>
            </a:xfrm>
          </p:grpSpPr>
          <p:sp>
            <p:nvSpPr>
              <p:cNvPr id="69" name="Textfeld 68"/>
              <p:cNvSpPr txBox="1"/>
              <p:nvPr/>
            </p:nvSpPr>
            <p:spPr>
              <a:xfrm rot="16200000">
                <a:off x="3467489" y="-909714"/>
                <a:ext cx="1520990" cy="298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Disease</a:t>
                </a:r>
                <a:r>
                  <a:rPr lang="de-AT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 Free </a:t>
                </a:r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urvival</a:t>
                </a:r>
                <a:endParaRPr lang="de-DE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70" name="Textfeld 69"/>
              <p:cNvSpPr txBox="1"/>
              <p:nvPr/>
            </p:nvSpPr>
            <p:spPr>
              <a:xfrm>
                <a:off x="4761854" y="1"/>
                <a:ext cx="718378" cy="24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Time (</a:t>
                </a:r>
                <a:r>
                  <a:rPr lang="de-AT" sz="5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months</a:t>
                </a:r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)</a:t>
                </a:r>
                <a:endParaRPr lang="de-DE" sz="5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71" name="Textfeld 70"/>
              <p:cNvSpPr txBox="1"/>
              <p:nvPr/>
            </p:nvSpPr>
            <p:spPr>
              <a:xfrm>
                <a:off x="5205310" y="-288429"/>
                <a:ext cx="753148" cy="403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b="1" dirty="0"/>
                  <a:t>p=0.334</a:t>
                </a:r>
                <a:endParaRPr lang="de-DE" sz="1000" b="1" dirty="0"/>
              </a:p>
            </p:txBody>
          </p:sp>
        </p:grpSp>
        <p:grpSp>
          <p:nvGrpSpPr>
            <p:cNvPr id="65" name="Gruppieren 64"/>
            <p:cNvGrpSpPr/>
            <p:nvPr/>
          </p:nvGrpSpPr>
          <p:grpSpPr>
            <a:xfrm>
              <a:off x="9186004" y="4282891"/>
              <a:ext cx="1698434" cy="1786198"/>
              <a:chOff x="2194137" y="-1584572"/>
              <a:chExt cx="1705525" cy="1786198"/>
            </a:xfrm>
          </p:grpSpPr>
          <p:sp>
            <p:nvSpPr>
              <p:cNvPr id="66" name="Textfeld 65"/>
              <p:cNvSpPr txBox="1"/>
              <p:nvPr/>
            </p:nvSpPr>
            <p:spPr>
              <a:xfrm rot="16200000">
                <a:off x="1582861" y="-973296"/>
                <a:ext cx="1520989" cy="298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Overall </a:t>
                </a:r>
                <a:r>
                  <a:rPr lang="de-AT" sz="9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urvival</a:t>
                </a:r>
                <a:endParaRPr lang="de-DE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67" name="Textfeld 66"/>
              <p:cNvSpPr txBox="1"/>
              <p:nvPr/>
            </p:nvSpPr>
            <p:spPr>
              <a:xfrm>
                <a:off x="2813973" y="-46533"/>
                <a:ext cx="718377" cy="24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Time (</a:t>
                </a:r>
                <a:r>
                  <a:rPr lang="de-AT" sz="500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months</a:t>
                </a:r>
                <a:r>
                  <a:rPr lang="de-AT" sz="5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)</a:t>
                </a:r>
                <a:endParaRPr lang="de-DE" sz="5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68" name="Textfeld 67"/>
              <p:cNvSpPr txBox="1"/>
              <p:nvPr/>
            </p:nvSpPr>
            <p:spPr>
              <a:xfrm>
                <a:off x="3165042" y="-348996"/>
                <a:ext cx="734620" cy="403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b="1" dirty="0"/>
                  <a:t>p=0.317</a:t>
                </a:r>
                <a:endParaRPr lang="de-DE" sz="1000" b="1" dirty="0"/>
              </a:p>
            </p:txBody>
          </p:sp>
        </p:grpSp>
        <p:sp>
          <p:nvSpPr>
            <p:cNvPr id="93" name="Textfeld 92"/>
            <p:cNvSpPr txBox="1"/>
            <p:nvPr/>
          </p:nvSpPr>
          <p:spPr>
            <a:xfrm>
              <a:off x="7638203" y="287635"/>
              <a:ext cx="3216799" cy="372239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AT" dirty="0" smtClean="0"/>
                <a:t>Type II</a:t>
              </a:r>
              <a:endParaRPr lang="de-DE" dirty="0"/>
            </a:p>
          </p:txBody>
        </p:sp>
      </p:grpSp>
      <p:sp>
        <p:nvSpPr>
          <p:cNvPr id="7168" name="Textfeld 7167"/>
          <p:cNvSpPr txBox="1"/>
          <p:nvPr/>
        </p:nvSpPr>
        <p:spPr>
          <a:xfrm>
            <a:off x="745789" y="215785"/>
            <a:ext cx="1296753" cy="356074"/>
          </a:xfrm>
          <a:prstGeom prst="rect">
            <a:avLst/>
          </a:prstGeom>
          <a:noFill/>
        </p:spPr>
        <p:txBody>
          <a:bodyPr wrap="square" lIns="78309" tIns="39155" rIns="78309" bIns="39155" rtlCol="0">
            <a:spAutoFit/>
          </a:bodyPr>
          <a:lstStyle/>
          <a:p>
            <a:r>
              <a:rPr lang="de-AT" dirty="0" err="1" smtClean="0"/>
              <a:t>Figure</a:t>
            </a:r>
            <a:r>
              <a:rPr lang="de-AT" dirty="0" smtClean="0"/>
              <a:t> </a:t>
            </a:r>
            <a:r>
              <a:rPr lang="de-AT" smtClean="0"/>
              <a:t>S2</a:t>
            </a:r>
            <a:endParaRPr lang="de-DE" dirty="0"/>
          </a:p>
        </p:txBody>
      </p:sp>
      <p:sp>
        <p:nvSpPr>
          <p:cNvPr id="64" name="Textfeld 117"/>
          <p:cNvSpPr txBox="1"/>
          <p:nvPr/>
        </p:nvSpPr>
        <p:spPr>
          <a:xfrm>
            <a:off x="2228357" y="1916832"/>
            <a:ext cx="3994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AT" sz="900" dirty="0"/>
              <a:t>high</a:t>
            </a:r>
            <a:endParaRPr lang="de-DE" sz="900" dirty="0"/>
          </a:p>
        </p:txBody>
      </p:sp>
      <p:sp>
        <p:nvSpPr>
          <p:cNvPr id="95" name="Textfeld 119"/>
          <p:cNvSpPr txBox="1"/>
          <p:nvPr/>
        </p:nvSpPr>
        <p:spPr>
          <a:xfrm>
            <a:off x="2242608" y="1550368"/>
            <a:ext cx="3618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AT" sz="900" dirty="0" err="1"/>
              <a:t>low</a:t>
            </a:r>
            <a:endParaRPr lang="de-DE" sz="900" dirty="0"/>
          </a:p>
        </p:txBody>
      </p:sp>
    </p:spTree>
    <p:extLst>
      <p:ext uri="{BB962C8B-B14F-4D97-AF65-F5344CB8AC3E}">
        <p14:creationId xmlns:p14="http://schemas.microsoft.com/office/powerpoint/2010/main" val="317337306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Office PowerPoint</Application>
  <PresentationFormat>Bildschirmpräsentation (4:3)</PresentationFormat>
  <Paragraphs>45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Tilak Gmb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iolab08</dc:creator>
  <cp:lastModifiedBy>biolab08 </cp:lastModifiedBy>
  <cp:revision>10</cp:revision>
  <dcterms:created xsi:type="dcterms:W3CDTF">2016-01-05T07:56:05Z</dcterms:created>
  <dcterms:modified xsi:type="dcterms:W3CDTF">2016-04-05T10:01:24Z</dcterms:modified>
</cp:coreProperties>
</file>